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591" r:id="rId2"/>
    <p:sldId id="589" r:id="rId3"/>
    <p:sldId id="592" r:id="rId4"/>
    <p:sldId id="593" r:id="rId5"/>
    <p:sldId id="594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7" autoAdjust="0"/>
    <p:restoredTop sz="77523" autoAdjust="0"/>
  </p:normalViewPr>
  <p:slideViewPr>
    <p:cSldViewPr snapToGrid="0">
      <p:cViewPr varScale="1">
        <p:scale>
          <a:sx n="74" d="100"/>
          <a:sy n="74" d="100"/>
        </p:scale>
        <p:origin x="630" y="54"/>
      </p:cViewPr>
      <p:guideLst/>
    </p:cSldViewPr>
  </p:slideViewPr>
  <p:outlineViewPr>
    <p:cViewPr>
      <p:scale>
        <a:sx n="33" d="100"/>
        <a:sy n="33" d="100"/>
      </p:scale>
      <p:origin x="0" y="-6552"/>
    </p:cViewPr>
  </p:outlineViewPr>
  <p:notesTextViewPr>
    <p:cViewPr>
      <p:scale>
        <a:sx n="125" d="100"/>
        <a:sy n="125" d="100"/>
      </p:scale>
      <p:origin x="0" y="0"/>
    </p:cViewPr>
  </p:notesTextViewPr>
  <p:notesViewPr>
    <p:cSldViewPr snapToGrid="0">
      <p:cViewPr varScale="1">
        <p:scale>
          <a:sx n="59" d="100"/>
          <a:sy n="59" d="100"/>
        </p:scale>
        <p:origin x="2528" y="76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1EFB8E-9A0F-487E-A7B9-F89EFE63B949}" type="datetimeFigureOut">
              <a:rPr lang="en-US" smtClean="0"/>
              <a:t>12/28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E836B69-7DC3-449B-9BCB-E1B881142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1342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here are no significant differences in the distribution of lipids in patients with gestational diabetes, hypertension, or </a:t>
            </a:r>
            <a:r>
              <a:rPr lang="en-US" dirty="0" err="1"/>
              <a:t>preclampsia</a:t>
            </a:r>
            <a:r>
              <a:rPr lang="en-US" dirty="0"/>
              <a:t>. ANOVA p-value &gt;0.05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E836B69-7DC3-449B-9BCB-E1B881142B9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22647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E836B69-7DC3-449B-9BCB-E1B881142B9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5192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344614-A757-42B4-8436-4AB3E62F16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B64269E-8DE6-436B-9EA9-347A20C97ED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6E2C6B-1D0B-43C6-91D1-A500164564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DD210-8D1F-4FC6-98C7-B382EEC34B25}" type="datetimeFigureOut">
              <a:rPr lang="en-US" smtClean="0"/>
              <a:t>12/2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C44C46-800C-4EE0-8165-35A3F51111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C153CB-2402-4276-91A7-2D35AA727A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C375D-F00F-4BC0-BFDB-105A89C50D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8902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C6C5E2-F076-41D2-A40C-B0508D14C8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D0B25D-56A3-449B-9E33-449B46114E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5D60DD-A567-48E9-B1D6-75378EDF81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DD210-8D1F-4FC6-98C7-B382EEC34B25}" type="datetimeFigureOut">
              <a:rPr lang="en-US" smtClean="0"/>
              <a:t>12/2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0AA9ED-ECD9-4C62-8C12-3207318178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64A6E7-385B-4A74-8A6D-218D56810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C375D-F00F-4BC0-BFDB-105A89C50D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5914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241E8D4-74BC-45EC-AA03-7999288426E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628B2DD-9E98-4D0A-8794-FCA81948E2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6F2B6F-2B80-4EF3-A234-21886C0D82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DD210-8D1F-4FC6-98C7-B382EEC34B25}" type="datetimeFigureOut">
              <a:rPr lang="en-US" smtClean="0"/>
              <a:t>12/2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3F2AD8-135F-4E2B-B5DE-B6590F437F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3FEB2E-89EB-449F-89C3-4EABA5908E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C375D-F00F-4BC0-BFDB-105A89C50D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88042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B1C1BB-3C99-4F4B-BBEA-C6B0E8CE52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197C0F-5DA9-4036-8203-015B36DA2E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6313F6-45A2-4A47-9298-574EB84C44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DD210-8D1F-4FC6-98C7-B382EEC34B25}" type="datetimeFigureOut">
              <a:rPr lang="en-US" smtClean="0"/>
              <a:t>12/2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FC5196-F7BF-40CE-AAD2-58237980C8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1936B1-288F-40AC-B0E3-A2E6828BE6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C375D-F00F-4BC0-BFDB-105A89C50D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30366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30B7F1-DBF5-4E14-BFDE-FFBEF89834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69E10A-34E7-4461-86D4-499D8BCA06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52ED6B-994B-4AB7-AABE-10CA6F4D91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DD210-8D1F-4FC6-98C7-B382EEC34B25}" type="datetimeFigureOut">
              <a:rPr lang="en-US" smtClean="0"/>
              <a:t>12/2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EE2454-BA54-471C-BBDA-04BC11169F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208F3E-CD3D-4958-AF0E-4525BC0204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C375D-F00F-4BC0-BFDB-105A89C50D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0382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325620-C643-47B5-BCF8-40B8515055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5539A9-7E6B-468B-8D61-054B1730DF8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5B5175-6FA1-4735-8080-8BD7F1E278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AF948C-74E9-4366-A745-19822536AB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DD210-8D1F-4FC6-98C7-B382EEC34B25}" type="datetimeFigureOut">
              <a:rPr lang="en-US" smtClean="0"/>
              <a:t>12/2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BAFC75-4FDF-4581-A572-134A8FB380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A7A543-5D56-4B9D-95B6-ACC5369A09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C375D-F00F-4BC0-BFDB-105A89C50D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61671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B24543-C1E1-4982-B469-93F2D8931F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F3FA7A-07DD-49B2-A6DE-67B8E701E9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E51B6D0-BCE2-45EC-8F24-63C92E4C6E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FE487AF-FFA0-4A1C-9BC3-E68AB9640CA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6872684-D2D1-45B5-B2C1-018F0C0F41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F704B2D-CF33-427E-BC80-A54C1CE29D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DD210-8D1F-4FC6-98C7-B382EEC34B25}" type="datetimeFigureOut">
              <a:rPr lang="en-US" smtClean="0"/>
              <a:t>12/28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558EC54-CF44-464A-9CB3-3E2AB3E174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1983F41-2A7B-46F9-9512-ED648EFDF2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C375D-F00F-4BC0-BFDB-105A89C50D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0208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19FFFE-C970-4772-9F02-FE1247D179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484BE7B-B876-44A9-92FC-7EA82BC6B0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DD210-8D1F-4FC6-98C7-B382EEC34B25}" type="datetimeFigureOut">
              <a:rPr lang="en-US" smtClean="0"/>
              <a:t>12/28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B0042C7-C994-4D87-B449-32A09C857D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1325FAC-BDA9-4698-AB17-2945F43827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C375D-F00F-4BC0-BFDB-105A89C50D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4947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FD4F2C2-0A7C-42CE-A906-F872DA045A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DD210-8D1F-4FC6-98C7-B382EEC34B25}" type="datetimeFigureOut">
              <a:rPr lang="en-US" smtClean="0"/>
              <a:t>12/28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E350098-CF9C-422D-99A4-475E599C0B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EA0D497-77A2-4A8B-AC2E-DE9998534F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C375D-F00F-4BC0-BFDB-105A89C50D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2867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956526-4771-427B-865C-72F35CD232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4BF79A-DCAD-4855-8BF0-94A9779ABFC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41F996-265C-4087-A255-04D2553342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973492-647A-40A9-A4B5-9F65A3B5AD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DD210-8D1F-4FC6-98C7-B382EEC34B25}" type="datetimeFigureOut">
              <a:rPr lang="en-US" smtClean="0"/>
              <a:t>12/2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5368F8-6470-404B-8C0D-19E3D8F823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9C02CF1-4B5B-48E7-826A-027A1C0A3E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C375D-F00F-4BC0-BFDB-105A89C50D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088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E4E99D-287D-4FCC-B7D5-A8623C7168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EBBDB4E-9158-47AD-8209-8D2A393717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182C9F-4207-4474-9615-7CA11B65F7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102285-6891-42C8-A314-76BC8AF9B8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DD210-8D1F-4FC6-98C7-B382EEC34B25}" type="datetimeFigureOut">
              <a:rPr lang="en-US" smtClean="0"/>
              <a:t>12/2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9BAB052-84E8-4B8F-AC64-AFF0A1B45D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C67A22-B741-4B53-8BD5-71B14C7EE6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C375D-F00F-4BC0-BFDB-105A89C50D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7552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2E98127-2983-4B97-AC4C-58F37BE3A9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BC0830-1FC0-4477-B164-ACCD47ED3F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31D32F-2DDC-4706-BCDC-FFB613084F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3DD210-8D1F-4FC6-98C7-B382EEC34B25}" type="datetimeFigureOut">
              <a:rPr lang="en-US" smtClean="0"/>
              <a:t>12/2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2AC596-108B-4557-BC5A-52BCD17FC0B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60ACFF-6EF8-4D0D-A1AA-DAD060C15AA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5C375D-F00F-4BC0-BFDB-105A89C50D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1119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5E0553F-F9B3-4E19-B882-00A75095B225}"/>
              </a:ext>
            </a:extLst>
          </p:cNvPr>
          <p:cNvSpPr txBox="1"/>
          <p:nvPr/>
        </p:nvSpPr>
        <p:spPr>
          <a:xfrm>
            <a:off x="5120640" y="2807746"/>
            <a:ext cx="16139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</a:t>
            </a:r>
          </a:p>
        </p:txBody>
      </p:sp>
    </p:spTree>
    <p:extLst>
      <p:ext uri="{BB962C8B-B14F-4D97-AF65-F5344CB8AC3E}">
        <p14:creationId xmlns:p14="http://schemas.microsoft.com/office/powerpoint/2010/main" val="14245002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BE9AB5BF-96DD-4E93-A8DA-5661ADE9883B}"/>
              </a:ext>
            </a:extLst>
          </p:cNvPr>
          <p:cNvSpPr txBox="1"/>
          <p:nvPr/>
        </p:nvSpPr>
        <p:spPr>
          <a:xfrm rot="16200000">
            <a:off x="-16399" y="2724946"/>
            <a:ext cx="17026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omponent 2 (9.2%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1DAC6FC-1FF7-412E-8DE2-5C670F7F83C8}"/>
              </a:ext>
            </a:extLst>
          </p:cNvPr>
          <p:cNvSpPr txBox="1"/>
          <p:nvPr/>
        </p:nvSpPr>
        <p:spPr>
          <a:xfrm rot="16200000">
            <a:off x="5208943" y="2725964"/>
            <a:ext cx="17940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omponent 2 (21.3%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E74FE04-5B08-47C6-8C70-AB6C61081044}"/>
              </a:ext>
            </a:extLst>
          </p:cNvPr>
          <p:cNvSpPr txBox="1"/>
          <p:nvPr/>
        </p:nvSpPr>
        <p:spPr>
          <a:xfrm>
            <a:off x="7825427" y="5379980"/>
            <a:ext cx="17940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omponent 1 (37.3%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0CE3933-7131-4923-991C-52C1690D0ADC}"/>
              </a:ext>
            </a:extLst>
          </p:cNvPr>
          <p:cNvSpPr txBox="1"/>
          <p:nvPr/>
        </p:nvSpPr>
        <p:spPr>
          <a:xfrm>
            <a:off x="2388805" y="5401232"/>
            <a:ext cx="17940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omponent 1 (46.5%)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4C0170E0-706D-4599-9CE9-7789E2D44116}"/>
              </a:ext>
            </a:extLst>
          </p:cNvPr>
          <p:cNvSpPr/>
          <p:nvPr/>
        </p:nvSpPr>
        <p:spPr>
          <a:xfrm>
            <a:off x="1519708" y="5619847"/>
            <a:ext cx="7934824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656080" marR="0" algn="l">
              <a:lnSpc>
                <a:spcPct val="95000"/>
              </a:lnSpc>
              <a:spcBef>
                <a:spcPts val="1200"/>
              </a:spcBef>
              <a:spcAft>
                <a:spcPts val="60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panose="020B0502040204020203" pitchFamily="34" charset="-34"/>
              </a:rPr>
              <a:t> </a:t>
            </a:r>
            <a:r>
              <a:rPr lang="en-US" sz="1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incipal Component Analysis (PCA) of lipids in serum of patients with gestational diabetes, gestational hypertension, and preeclampsia at Visit 1 and Visit 2. There are no significantly dysregulated lipids among patients with cardiometabolic disease (CMD).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425A2733-E098-4933-B025-A39369635DF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rcRect l="4664" t="6153" r="5942" b="6191"/>
          <a:stretch/>
        </p:blipFill>
        <p:spPr>
          <a:xfrm>
            <a:off x="988813" y="929621"/>
            <a:ext cx="4538524" cy="4450359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EB8A9408-33BD-4B4B-9303-27823F598E8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rcRect l="6178" t="5986" r="5909" b="5813"/>
          <a:stretch/>
        </p:blipFill>
        <p:spPr>
          <a:xfrm>
            <a:off x="6259840" y="906974"/>
            <a:ext cx="4458512" cy="447300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5B19507-2185-44C7-977C-EDC93A61BF3D}"/>
              </a:ext>
            </a:extLst>
          </p:cNvPr>
          <p:cNvSpPr txBox="1"/>
          <p:nvPr/>
        </p:nvSpPr>
        <p:spPr>
          <a:xfrm>
            <a:off x="9619444" y="4828605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Visit 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3FC0F53-3407-4783-9C64-32DF9410EDFB}"/>
              </a:ext>
            </a:extLst>
          </p:cNvPr>
          <p:cNvSpPr txBox="1"/>
          <p:nvPr/>
        </p:nvSpPr>
        <p:spPr>
          <a:xfrm>
            <a:off x="4770204" y="4830029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Visit 1</a:t>
            </a:r>
          </a:p>
        </p:txBody>
      </p:sp>
    </p:spTree>
    <p:extLst>
      <p:ext uri="{BB962C8B-B14F-4D97-AF65-F5344CB8AC3E}">
        <p14:creationId xmlns:p14="http://schemas.microsoft.com/office/powerpoint/2010/main" val="27781086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9058A2C8-D3A7-4CCB-9484-7ECE9C99AE7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36784834"/>
              </p:ext>
            </p:extLst>
          </p:nvPr>
        </p:nvGraphicFramePr>
        <p:xfrm>
          <a:off x="158750" y="808848"/>
          <a:ext cx="5937250" cy="3288221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2000885">
                  <a:extLst>
                    <a:ext uri="{9D8B030D-6E8A-4147-A177-3AD203B41FA5}">
                      <a16:colId xmlns:a16="http://schemas.microsoft.com/office/drawing/2014/main" val="1383547807"/>
                    </a:ext>
                  </a:extLst>
                </a:gridCol>
                <a:gridCol w="2041525">
                  <a:extLst>
                    <a:ext uri="{9D8B030D-6E8A-4147-A177-3AD203B41FA5}">
                      <a16:colId xmlns:a16="http://schemas.microsoft.com/office/drawing/2014/main" val="3287851149"/>
                    </a:ext>
                  </a:extLst>
                </a:gridCol>
                <a:gridCol w="1894840">
                  <a:extLst>
                    <a:ext uri="{9D8B030D-6E8A-4147-A177-3AD203B41FA5}">
                      <a16:colId xmlns:a16="http://schemas.microsoft.com/office/drawing/2014/main" val="56335745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LC Parameters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4977680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Palatino Linotype" panose="02040502050505030304" pitchFamily="18" charset="0"/>
                        </a:rPr>
                        <a:t>Time (min)</a:t>
                      </a:r>
                      <a:endParaRPr lang="en-US" sz="1400" b="1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Palatino Linotype" panose="02040502050505030304" pitchFamily="18" charset="0"/>
                        </a:rPr>
                        <a:t>Percent A: 10mM NH4OAc in water</a:t>
                      </a:r>
                      <a:endParaRPr lang="en-US" sz="1400" b="1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Palatino Linotype" panose="02040502050505030304" pitchFamily="18" charset="0"/>
                        </a:rPr>
                        <a:t>Percent B: 10mM NH4OAc in ACN</a:t>
                      </a:r>
                      <a:endParaRPr lang="en-US" sz="1400" b="1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50144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0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9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10</a:t>
                      </a:r>
                      <a:endParaRPr lang="en-US" sz="14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8776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0.5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9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1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098913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5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50</a:t>
                      </a:r>
                      <a:endParaRPr lang="en-US" sz="14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269134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5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5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87823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2.1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25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75</a:t>
                      </a:r>
                      <a:endParaRPr lang="en-US" sz="14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94702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5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25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75</a:t>
                      </a:r>
                      <a:endParaRPr lang="en-US" sz="14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63009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7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15</a:t>
                      </a:r>
                      <a:endParaRPr lang="en-US" sz="14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85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2964656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12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15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85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098116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12.1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</a:t>
                      </a:r>
                      <a:endParaRPr lang="en-US" sz="14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10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040079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14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10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417011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15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9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1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00570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16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9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1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02321745"/>
                  </a:ext>
                </a:extLst>
              </a:tr>
            </a:tbl>
          </a:graphicData>
        </a:graphic>
      </p:graphicFrame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1A3BC9A8-F170-4224-BCFB-1D99F908001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45458314"/>
              </p:ext>
            </p:extLst>
          </p:nvPr>
        </p:nvGraphicFramePr>
        <p:xfrm>
          <a:off x="158750" y="4091735"/>
          <a:ext cx="5937250" cy="2622804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2614886">
                  <a:extLst>
                    <a:ext uri="{9D8B030D-6E8A-4147-A177-3AD203B41FA5}">
                      <a16:colId xmlns:a16="http://schemas.microsoft.com/office/drawing/2014/main" val="106724319"/>
                    </a:ext>
                  </a:extLst>
                </a:gridCol>
                <a:gridCol w="1713186">
                  <a:extLst>
                    <a:ext uri="{9D8B030D-6E8A-4147-A177-3AD203B41FA5}">
                      <a16:colId xmlns:a16="http://schemas.microsoft.com/office/drawing/2014/main" val="480768127"/>
                    </a:ext>
                  </a:extLst>
                </a:gridCol>
                <a:gridCol w="1609178">
                  <a:extLst>
                    <a:ext uri="{9D8B030D-6E8A-4147-A177-3AD203B41FA5}">
                      <a16:colId xmlns:a16="http://schemas.microsoft.com/office/drawing/2014/main" val="1296755739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Mass Spec. Parameters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231797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n-US" sz="1400" b="1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Palatino Linotype" panose="02040502050505030304" pitchFamily="18" charset="0"/>
                        </a:rPr>
                        <a:t>Negative polarity</a:t>
                      </a:r>
                      <a:endParaRPr lang="en-US" sz="1400" b="1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Palatino Linotype" panose="02040502050505030304" pitchFamily="18" charset="0"/>
                        </a:rPr>
                        <a:t>Positive polarity</a:t>
                      </a:r>
                      <a:endParaRPr lang="en-US" sz="1400" b="1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47318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Curtain gas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2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2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501807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Collision Gas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Low</a:t>
                      </a:r>
                      <a:endParaRPr lang="en-US" sz="14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Low</a:t>
                      </a:r>
                      <a:endParaRPr lang="en-US" sz="14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26991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 err="1">
                          <a:effectLst/>
                          <a:latin typeface="Palatino Linotype" panose="02040502050505030304" pitchFamily="18" charset="0"/>
                        </a:rPr>
                        <a:t>IonSpray</a:t>
                      </a: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 Voltage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-450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5000</a:t>
                      </a:r>
                      <a:endParaRPr lang="en-US" sz="14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845436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Temperature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65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65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94904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Ion Source Gas 1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6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55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208391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Ion Source Gas 2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5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60</a:t>
                      </a:r>
                      <a:endParaRPr lang="en-US" sz="14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64363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 err="1">
                          <a:effectLst/>
                          <a:latin typeface="Palatino Linotype" panose="02040502050505030304" pitchFamily="18" charset="0"/>
                        </a:rPr>
                        <a:t>Declustering</a:t>
                      </a: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 Potential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-20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90</a:t>
                      </a:r>
                      <a:endParaRPr lang="en-US" sz="14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598220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Entrance Potential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-1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1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603358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Collision Energy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-4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47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957863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Collision Cell Exit Potential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-11</a:t>
                      </a:r>
                      <a:endParaRPr lang="en-US" sz="14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18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54791533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8C72D46F-2401-4581-BC91-9AE4051BFDF2}"/>
              </a:ext>
            </a:extLst>
          </p:cNvPr>
          <p:cNvSpPr txBox="1"/>
          <p:nvPr/>
        </p:nvSpPr>
        <p:spPr>
          <a:xfrm>
            <a:off x="158750" y="439516"/>
            <a:ext cx="39248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xylipin and Endocannabinoid Analysi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F80A795-32B1-1CD7-835F-61D8D20B7791}"/>
              </a:ext>
            </a:extLst>
          </p:cNvPr>
          <p:cNvSpPr txBox="1"/>
          <p:nvPr/>
        </p:nvSpPr>
        <p:spPr>
          <a:xfrm>
            <a:off x="6735651" y="566670"/>
            <a:ext cx="292350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able S1: LC and mass spectrometry parameters for oxylipin and endocannabinoid analysi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498743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45DA72E1-FDCA-43FE-9326-F559E9B1B82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98692247"/>
              </p:ext>
            </p:extLst>
          </p:nvPr>
        </p:nvGraphicFramePr>
        <p:xfrm>
          <a:off x="2869324" y="172185"/>
          <a:ext cx="6453352" cy="6513630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3647090">
                  <a:extLst>
                    <a:ext uri="{9D8B030D-6E8A-4147-A177-3AD203B41FA5}">
                      <a16:colId xmlns:a16="http://schemas.microsoft.com/office/drawing/2014/main" val="3283125912"/>
                    </a:ext>
                  </a:extLst>
                </a:gridCol>
                <a:gridCol w="945931">
                  <a:extLst>
                    <a:ext uri="{9D8B030D-6E8A-4147-A177-3AD203B41FA5}">
                      <a16:colId xmlns:a16="http://schemas.microsoft.com/office/drawing/2014/main" val="2143569720"/>
                    </a:ext>
                  </a:extLst>
                </a:gridCol>
                <a:gridCol w="698081">
                  <a:extLst>
                    <a:ext uri="{9D8B030D-6E8A-4147-A177-3AD203B41FA5}">
                      <a16:colId xmlns:a16="http://schemas.microsoft.com/office/drawing/2014/main" val="4040605702"/>
                    </a:ext>
                  </a:extLst>
                </a:gridCol>
                <a:gridCol w="1162250">
                  <a:extLst>
                    <a:ext uri="{9D8B030D-6E8A-4147-A177-3AD203B41FA5}">
                      <a16:colId xmlns:a16="http://schemas.microsoft.com/office/drawing/2014/main" val="1625077944"/>
                    </a:ext>
                  </a:extLst>
                </a:gridCol>
              </a:tblGrid>
              <a:tr h="34106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Lipid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Q1 Mass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Q3 Mass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Ionization Mod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/>
                </a:tc>
                <a:extLst>
                  <a:ext uri="{0D108BD9-81ED-4DB2-BD59-A6C34878D82A}">
                    <a16:rowId xmlns:a16="http://schemas.microsoft.com/office/drawing/2014/main" val="1818953643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9,10 DIHOME 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313.2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201.0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Nega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99640842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PGE E2 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351.2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315.1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Nega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69574039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20- HETE 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Palatino Linotype" panose="02040502050505030304" pitchFamily="18" charset="0"/>
                        </a:rPr>
                        <a:t>319.2 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289.2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Nega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06462624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9-HETE 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319.2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167.2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Nega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8676703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14,15 DHET 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337.2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207.0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Nega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28994608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>
                          <a:effectLst/>
                          <a:latin typeface="Palatino Linotype" panose="02040502050505030304" pitchFamily="18" charset="0"/>
                        </a:rPr>
                        <a:t>5 HETE </a:t>
                      </a:r>
                      <a:endParaRPr lang="en-US" sz="1000" b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319.2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115.1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Nega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5585930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12 R-HETE 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319.2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179.1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Nega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45370883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11,12-DHET 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337.2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167.1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Nega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9693629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>
                          <a:effectLst/>
                          <a:latin typeface="Palatino Linotype" panose="02040502050505030304" pitchFamily="18" charset="0"/>
                        </a:rPr>
                        <a:t>8,9-DHET </a:t>
                      </a:r>
                      <a:endParaRPr lang="en-US" sz="1000" b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337.2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127.2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Nega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41049152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>
                          <a:effectLst/>
                          <a:latin typeface="Palatino Linotype" panose="02040502050505030304" pitchFamily="18" charset="0"/>
                        </a:rPr>
                        <a:t>5,6 EET </a:t>
                      </a:r>
                      <a:endParaRPr lang="en-US" sz="1000" b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Palatino Linotype" panose="02040502050505030304" pitchFamily="18" charset="0"/>
                        </a:rPr>
                        <a:t>319.2 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191.1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Nega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60547916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5,6-DHET 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Palatino Linotype" panose="02040502050505030304" pitchFamily="18" charset="0"/>
                        </a:rPr>
                        <a:t>337.2 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71.0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Nega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3230374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>
                          <a:effectLst/>
                          <a:latin typeface="Palatino Linotype" panose="02040502050505030304" pitchFamily="18" charset="0"/>
                        </a:rPr>
                        <a:t>TXB2 </a:t>
                      </a:r>
                      <a:endParaRPr lang="en-US" sz="1000" b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Palatino Linotype" panose="02040502050505030304" pitchFamily="18" charset="0"/>
                        </a:rPr>
                        <a:t>369.2 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169.1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Nega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4878727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12(13)-EPOME 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Palatino Linotype" panose="02040502050505030304" pitchFamily="18" charset="0"/>
                        </a:rPr>
                        <a:t>295.2 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195.1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Nega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55339372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13 HODE 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Palatino Linotype" panose="02040502050505030304" pitchFamily="18" charset="0"/>
                        </a:rPr>
                        <a:t>295.2 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195.1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Nega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0738347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>
                          <a:effectLst/>
                          <a:latin typeface="Palatino Linotype" panose="02040502050505030304" pitchFamily="18" charset="0"/>
                        </a:rPr>
                        <a:t>PGF2A </a:t>
                      </a:r>
                      <a:endParaRPr lang="en-US" sz="1000" b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Palatino Linotype" panose="02040502050505030304" pitchFamily="18" charset="0"/>
                        </a:rPr>
                        <a:t>353.2 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193.3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Nega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22606299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14(15)-EET / 15-HETE 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Palatino Linotype" panose="02040502050505030304" pitchFamily="18" charset="0"/>
                        </a:rPr>
                        <a:t>319.2 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219.0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Nega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10910119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>
                          <a:effectLst/>
                          <a:latin typeface="Palatino Linotype" panose="02040502050505030304" pitchFamily="18" charset="0"/>
                        </a:rPr>
                        <a:t>LTB4 </a:t>
                      </a:r>
                      <a:endParaRPr lang="en-US" sz="1000" b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335.2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195.1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Nega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52808504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8(9)-EET 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Palatino Linotype" panose="02040502050505030304" pitchFamily="18" charset="0"/>
                        </a:rPr>
                        <a:t>319.2 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69.2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Nega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69239311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>
                          <a:effectLst/>
                          <a:latin typeface="Palatino Linotype" panose="02040502050505030304" pitchFamily="18" charset="0"/>
                        </a:rPr>
                        <a:t>11(12)-EET </a:t>
                      </a:r>
                      <a:endParaRPr lang="en-US" sz="1000" b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Palatino Linotype" panose="02040502050505030304" pitchFamily="18" charset="0"/>
                        </a:rPr>
                        <a:t>319.2 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167.1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Nega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9819962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PGE2 </a:t>
                      </a:r>
                      <a:r>
                        <a:rPr lang="en-US" sz="1000" b="0" dirty="0" err="1">
                          <a:effectLst/>
                          <a:latin typeface="Palatino Linotype" panose="02040502050505030304" pitchFamily="18" charset="0"/>
                        </a:rPr>
                        <a:t>Ethanolamide</a:t>
                      </a: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 (PGE2-EA)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Palatino Linotype" panose="02040502050505030304" pitchFamily="18" charset="0"/>
                        </a:rPr>
                        <a:t>396.5 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271.3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Posi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1986315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Oleoyl </a:t>
                      </a:r>
                      <a:r>
                        <a:rPr lang="en-US" sz="1000" b="0" dirty="0" err="1">
                          <a:effectLst/>
                          <a:latin typeface="Palatino Linotype" panose="02040502050505030304" pitchFamily="18" charset="0"/>
                        </a:rPr>
                        <a:t>Ethanolamide</a:t>
                      </a: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 (OEA) 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326.4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62.1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Posi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24357163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>
                          <a:effectLst/>
                          <a:latin typeface="Palatino Linotype" panose="02040502050505030304" pitchFamily="18" charset="0"/>
                        </a:rPr>
                        <a:t>Palmitoyl Ethanolamide </a:t>
                      </a:r>
                      <a:endParaRPr lang="en-US" sz="1000" b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Palatino Linotype" panose="02040502050505030304" pitchFamily="18" charset="0"/>
                        </a:rPr>
                        <a:t>300.4 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62.1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Posi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51405769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Resolvin D1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375.2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141.0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Nega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99483464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Resolvin D2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375.2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175.1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Nega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58648949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Resolvin D3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375.2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147.1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Nega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71616253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Resolvin E1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349.2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195.1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Nega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0818941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ARA-</a:t>
                      </a:r>
                      <a:r>
                        <a:rPr lang="en-US" sz="1000" b="0" dirty="0" err="1">
                          <a:effectLst/>
                          <a:latin typeface="Palatino Linotype" panose="02040502050505030304" pitchFamily="18" charset="0"/>
                        </a:rPr>
                        <a:t>Ethanolamide</a:t>
                      </a: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 (AEA) 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Palatino Linotype" panose="02040502050505030304" pitchFamily="18" charset="0"/>
                        </a:rPr>
                        <a:t>348.4 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62.1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Posi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30130178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 err="1">
                          <a:effectLst/>
                          <a:latin typeface="Palatino Linotype" panose="02040502050505030304" pitchFamily="18" charset="0"/>
                        </a:rPr>
                        <a:t>Docosahexaenoyl</a:t>
                      </a: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r>
                        <a:rPr lang="en-US" sz="1000" b="0" dirty="0" err="1">
                          <a:effectLst/>
                          <a:latin typeface="Palatino Linotype" panose="02040502050505030304" pitchFamily="18" charset="0"/>
                        </a:rPr>
                        <a:t>Ethanolamide</a:t>
                      </a: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 (DHEA)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372.4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62.1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Posi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78242449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>
                          <a:effectLst/>
                          <a:latin typeface="Palatino Linotype" panose="02040502050505030304" pitchFamily="18" charset="0"/>
                        </a:rPr>
                        <a:t>Linoleoyl Ethanolamide (LEA) </a:t>
                      </a:r>
                      <a:endParaRPr lang="en-US" sz="1000" b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Palatino Linotype" panose="02040502050505030304" pitchFamily="18" charset="0"/>
                        </a:rPr>
                        <a:t>324.4 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62.1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Posi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13922140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Stearoyl </a:t>
                      </a:r>
                      <a:r>
                        <a:rPr lang="en-US" sz="1000" b="0" dirty="0" err="1">
                          <a:effectLst/>
                          <a:latin typeface="Palatino Linotype" panose="02040502050505030304" pitchFamily="18" charset="0"/>
                        </a:rPr>
                        <a:t>Ethanolamide</a:t>
                      </a: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 (</a:t>
                      </a:r>
                      <a:r>
                        <a:rPr lang="en-US" sz="1000" b="0" dirty="0" err="1">
                          <a:effectLst/>
                          <a:latin typeface="Palatino Linotype" panose="02040502050505030304" pitchFamily="18" charset="0"/>
                        </a:rPr>
                        <a:t>ceramid</a:t>
                      </a: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) 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328.4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62.1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Posi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3353584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oxy-Arachidonoyl </a:t>
                      </a:r>
                      <a:r>
                        <a:rPr lang="en-US" sz="1000" b="0" dirty="0" err="1">
                          <a:effectLst/>
                          <a:latin typeface="Palatino Linotype" panose="02040502050505030304" pitchFamily="18" charset="0"/>
                        </a:rPr>
                        <a:t>Ethanolamide</a:t>
                      </a: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 (oxy-AEA) 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Palatino Linotype" panose="02040502050505030304" pitchFamily="18" charset="0"/>
                        </a:rPr>
                        <a:t>364 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76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Posi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4688143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2-Arachidonoyl Glycerol (2AG) 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Palatino Linotype" panose="02040502050505030304" pitchFamily="18" charset="0"/>
                        </a:rPr>
                        <a:t>379.4 </a:t>
                      </a:r>
                      <a:endParaRPr lang="en-US" sz="10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135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Posi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65933808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 err="1">
                          <a:effectLst/>
                          <a:latin typeface="Palatino Linotype" panose="02040502050505030304" pitchFamily="18" charset="0"/>
                        </a:rPr>
                        <a:t>Docosatetraenoyl</a:t>
                      </a: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r>
                        <a:rPr lang="en-US" sz="1000" b="0" dirty="0" err="1">
                          <a:effectLst/>
                          <a:latin typeface="Palatino Linotype" panose="02040502050505030304" pitchFamily="18" charset="0"/>
                        </a:rPr>
                        <a:t>Ethanolamide</a:t>
                      </a: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 (DEA) 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376.6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62.1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Posi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07302535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>
                          <a:effectLst/>
                          <a:latin typeface="Palatino Linotype" panose="02040502050505030304" pitchFamily="18" charset="0"/>
                        </a:rPr>
                        <a:t>alpha-linolenoyl ethanolamide(ALEA) </a:t>
                      </a:r>
                      <a:endParaRPr lang="en-US" sz="1000" b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322.4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62.1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Posi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00617380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oleamide 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282.5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247.4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Posi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0257467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 err="1">
                          <a:effectLst/>
                          <a:latin typeface="Palatino Linotype" panose="02040502050505030304" pitchFamily="18" charset="0"/>
                        </a:rPr>
                        <a:t>dihomo</a:t>
                      </a: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-gamma-linolenoyl </a:t>
                      </a:r>
                      <a:r>
                        <a:rPr lang="en-US" sz="1000" b="0" dirty="0" err="1">
                          <a:effectLst/>
                          <a:latin typeface="Palatino Linotype" panose="02040502050505030304" pitchFamily="18" charset="0"/>
                        </a:rPr>
                        <a:t>ethanolamide</a:t>
                      </a: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350.4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62.1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Posi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19844610"/>
                  </a:ext>
                </a:extLst>
              </a:tr>
              <a:tr h="1668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effectLst/>
                          <a:latin typeface="Palatino Linotype" panose="02040502050505030304" pitchFamily="18" charset="0"/>
                        </a:rPr>
                        <a:t>PGE-2 Glycerol Ester</a:t>
                      </a:r>
                      <a:endParaRPr lang="en-US" sz="10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427.6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297.1 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Palatino Linotype" panose="02040502050505030304" pitchFamily="18" charset="0"/>
                        </a:rPr>
                        <a:t>Positive</a:t>
                      </a:r>
                      <a:endParaRPr lang="en-US" sz="10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51411" marR="51411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836393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4733D1DB-C572-D457-6689-D803B3EA5110}"/>
              </a:ext>
            </a:extLst>
          </p:cNvPr>
          <p:cNvSpPr txBox="1"/>
          <p:nvPr/>
        </p:nvSpPr>
        <p:spPr>
          <a:xfrm>
            <a:off x="605307" y="412124"/>
            <a:ext cx="189319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able S2: Table of MRM transitions for oxylipin and endocannabinoid analysi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415316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A37E3BEE-F1DF-F459-F6D9-3332B4DFD98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34335866"/>
              </p:ext>
            </p:extLst>
          </p:nvPr>
        </p:nvGraphicFramePr>
        <p:xfrm>
          <a:off x="6254750" y="808848"/>
          <a:ext cx="4854684" cy="2185670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1617882">
                  <a:extLst>
                    <a:ext uri="{9D8B030D-6E8A-4147-A177-3AD203B41FA5}">
                      <a16:colId xmlns:a16="http://schemas.microsoft.com/office/drawing/2014/main" val="729791301"/>
                    </a:ext>
                  </a:extLst>
                </a:gridCol>
                <a:gridCol w="1618401">
                  <a:extLst>
                    <a:ext uri="{9D8B030D-6E8A-4147-A177-3AD203B41FA5}">
                      <a16:colId xmlns:a16="http://schemas.microsoft.com/office/drawing/2014/main" val="2191123850"/>
                    </a:ext>
                  </a:extLst>
                </a:gridCol>
                <a:gridCol w="1618401">
                  <a:extLst>
                    <a:ext uri="{9D8B030D-6E8A-4147-A177-3AD203B41FA5}">
                      <a16:colId xmlns:a16="http://schemas.microsoft.com/office/drawing/2014/main" val="211795738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LC Parameters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448984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Palatino Linotype" panose="02040502050505030304" pitchFamily="18" charset="0"/>
                        </a:rPr>
                        <a:t>Time (min)</a:t>
                      </a:r>
                      <a:endParaRPr lang="en-US" sz="1400" b="1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Palatino Linotype" panose="02040502050505030304" pitchFamily="18" charset="0"/>
                        </a:rPr>
                        <a:t>60:40 </a:t>
                      </a:r>
                      <a:r>
                        <a:rPr lang="en-US" sz="1400" b="1" dirty="0" err="1">
                          <a:effectLst/>
                          <a:latin typeface="Palatino Linotype" panose="02040502050505030304" pitchFamily="18" charset="0"/>
                        </a:rPr>
                        <a:t>ACN:Water</a:t>
                      </a:r>
                      <a:r>
                        <a:rPr lang="en-US" sz="1400" b="1" dirty="0"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endParaRPr lang="en-US" sz="1400" b="1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Palatino Linotype" panose="02040502050505030304" pitchFamily="18" charset="0"/>
                        </a:rPr>
                        <a:t>90:10 IPA: ACN </a:t>
                      </a:r>
                      <a:endParaRPr lang="en-US" sz="1400" b="1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4463117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0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9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1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510502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0.5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9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10</a:t>
                      </a:r>
                      <a:endParaRPr lang="en-US" sz="14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502557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5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50</a:t>
                      </a:r>
                      <a:endParaRPr lang="en-US" sz="14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60173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50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50</a:t>
                      </a:r>
                      <a:endParaRPr lang="en-US" sz="14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19171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2.1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25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75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722636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5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25</a:t>
                      </a:r>
                      <a:endParaRPr lang="en-US" sz="140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75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376545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7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15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85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707394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12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15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85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20854449"/>
                  </a:ext>
                </a:extLst>
              </a:tr>
            </a:tbl>
          </a:graphicData>
        </a:graphic>
      </p:graphicFrame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0A1D32A5-87A8-95F0-9BFE-F817A4ECD6A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44767960"/>
              </p:ext>
            </p:extLst>
          </p:nvPr>
        </p:nvGraphicFramePr>
        <p:xfrm>
          <a:off x="6254750" y="3002818"/>
          <a:ext cx="4854684" cy="2622804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3027872">
                  <a:extLst>
                    <a:ext uri="{9D8B030D-6E8A-4147-A177-3AD203B41FA5}">
                      <a16:colId xmlns:a16="http://schemas.microsoft.com/office/drawing/2014/main" val="107353214"/>
                    </a:ext>
                  </a:extLst>
                </a:gridCol>
                <a:gridCol w="1826812">
                  <a:extLst>
                    <a:ext uri="{9D8B030D-6E8A-4147-A177-3AD203B41FA5}">
                      <a16:colId xmlns:a16="http://schemas.microsoft.com/office/drawing/2014/main" val="389462981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Mass Spec. Parameters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298805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Palatino Linotype" panose="02040502050505030304" pitchFamily="18" charset="0"/>
                        </a:rPr>
                        <a:t>Negative polarity</a:t>
                      </a:r>
                      <a:endParaRPr lang="en-US" sz="1400" b="1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124912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Curtain gas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20 arb. units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031852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Collision Gas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Low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04309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 err="1">
                          <a:effectLst/>
                          <a:latin typeface="Palatino Linotype" panose="02040502050505030304" pitchFamily="18" charset="0"/>
                        </a:rPr>
                        <a:t>IonSpray</a:t>
                      </a: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 Voltage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-4500 V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5062477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Temperature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650C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076924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Ion Source Gas 1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55 arb. units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8328127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Ion Source Gas 2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60 arb. units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003509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 err="1">
                          <a:effectLst/>
                          <a:latin typeface="Palatino Linotype" panose="02040502050505030304" pitchFamily="18" charset="0"/>
                        </a:rPr>
                        <a:t>Declustering</a:t>
                      </a: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 Potential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-90 arb. units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08726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Entrance Potential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-10eV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078114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Collision Energy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-30eV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748248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Palatino Linotype" panose="02040502050505030304" pitchFamily="18" charset="0"/>
                        </a:rPr>
                        <a:t>Collision Cell Exit Potential</a:t>
                      </a:r>
                      <a:endParaRPr lang="en-US" sz="1400" b="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-11eV</a:t>
                      </a:r>
                      <a:endParaRPr lang="en-US" sz="1400" dirty="0">
                        <a:effectLst/>
                        <a:latin typeface="Palatino Linotype" panose="02040502050505030304" pitchFamily="18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2823987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72C975B3-E2A3-FA0E-5B49-EBDA82E3FC76}"/>
              </a:ext>
            </a:extLst>
          </p:cNvPr>
          <p:cNvSpPr txBox="1"/>
          <p:nvPr/>
        </p:nvSpPr>
        <p:spPr>
          <a:xfrm>
            <a:off x="6254750" y="439516"/>
            <a:ext cx="22638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Phospholipid Analysi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43BC230-FFE4-1652-85C9-3E53C488E6A6}"/>
              </a:ext>
            </a:extLst>
          </p:cNvPr>
          <p:cNvSpPr txBox="1"/>
          <p:nvPr/>
        </p:nvSpPr>
        <p:spPr>
          <a:xfrm>
            <a:off x="734096" y="553792"/>
            <a:ext cx="303941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ble S3:  LC and mass spectrometry parameters for phospholipid analysis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926924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216</TotalTime>
  <Words>573</Words>
  <Application>Microsoft Office PowerPoint</Application>
  <PresentationFormat>Widescreen</PresentationFormat>
  <Paragraphs>293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er-Smith, Kristal</dc:creator>
  <cp:lastModifiedBy>MDPI</cp:lastModifiedBy>
  <cp:revision>213</cp:revision>
  <dcterms:created xsi:type="dcterms:W3CDTF">2021-11-22T23:59:05Z</dcterms:created>
  <dcterms:modified xsi:type="dcterms:W3CDTF">2022-12-28T08:24:38Z</dcterms:modified>
</cp:coreProperties>
</file>